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00438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6902" autoAdjust="0"/>
    <p:restoredTop sz="94660"/>
  </p:normalViewPr>
  <p:slideViewPr>
    <p:cSldViewPr snapToGrid="0">
      <p:cViewPr>
        <p:scale>
          <a:sx n="123" d="100"/>
          <a:sy n="123" d="100"/>
        </p:scale>
        <p:origin x="712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51323"/>
            <a:ext cx="10363200" cy="5640152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08981"/>
            <a:ext cx="9144000" cy="3911355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036968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8416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2524"/>
            <a:ext cx="2628900" cy="1372912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2524"/>
            <a:ext cx="7734300" cy="13729122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2149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4183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38864"/>
            <a:ext cx="10515600" cy="6738931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41548"/>
            <a:ext cx="10515600" cy="3543845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7516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12617"/>
            <a:ext cx="5181600" cy="102790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12617"/>
            <a:ext cx="5181600" cy="1027902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499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2527"/>
            <a:ext cx="10515600" cy="313133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71359"/>
            <a:ext cx="5157787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17660"/>
            <a:ext cx="5157787" cy="870398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71359"/>
            <a:ext cx="5183188" cy="194630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17660"/>
            <a:ext cx="5183188" cy="8703987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589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14938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293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32567"/>
            <a:ext cx="6172200" cy="1151281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306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0029"/>
            <a:ext cx="3932237" cy="3780102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32567"/>
            <a:ext cx="6172200" cy="11512811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60131"/>
            <a:ext cx="3932237" cy="900399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40466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2527"/>
            <a:ext cx="10515600" cy="313133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12617"/>
            <a:ext cx="10515600" cy="1027902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D61708-11D6-4FB5-BBA0-7CEC678E8E03}" type="datetimeFigureOut">
              <a:rPr lang="zh-CN" altLang="en-US" smtClean="0"/>
              <a:t>2022/7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15410"/>
            <a:ext cx="41148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15410"/>
            <a:ext cx="2743200" cy="86252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28228-16E0-44A6-98C8-307B46FFD5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2397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5" Type="http://schemas.openxmlformats.org/officeDocument/2006/relationships/image" Target="../media/image24.jpe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24" Type="http://schemas.openxmlformats.org/officeDocument/2006/relationships/image" Target="../media/image23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23" Type="http://schemas.openxmlformats.org/officeDocument/2006/relationships/image" Target="../media/image22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矩形 136"/>
          <p:cNvSpPr/>
          <p:nvPr/>
        </p:nvSpPr>
        <p:spPr>
          <a:xfrm>
            <a:off x="46840" y="14580462"/>
            <a:ext cx="12137938" cy="15411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zh-CN" sz="1569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 </a:t>
            </a:r>
            <a:r>
              <a:rPr lang="en-US" altLang="zh-CN" sz="15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s and QQ plots of GWAS for Cd and As concentrations in 2019 and 2020 in the 307 rice accessions.</a:t>
            </a:r>
          </a:p>
          <a:p>
            <a:r>
              <a:rPr lang="en-US" altLang="zh-CN" sz="1569" dirty="0">
                <a:latin typeface="Times New Roman" panose="02020603050405020304" pitchFamily="18" charset="0"/>
                <a:cs typeface="Times New Roman" panose="02020603050405020304" pitchFamily="18" charset="0"/>
              </a:rPr>
              <a:t>CBN, Cd concentration in brown rice in normal condition; CMN, Cd concentration in milled rice in normal condition; ABN, As concentration in brown rice in normal condition; AMN, As concentration in milled rice in normal condition; CBT, Cd concentration in brown rice in treatment condition; CMT, Cd concentration in milled rice in treatment condition; ABT, As concentration in brown rice in treatment condition; AMT, As concentration in milled rice in treatment condition; RCB, ratio of the Cd concentration in brown rice; RCM, ratio of the Cd concentration in milled rice; RAB, ratio of the As concentration in brown rice; RAM, ratio of the As concentration in milled rice.</a:t>
            </a:r>
            <a:endParaRPr lang="zh-CN" altLang="en-US" sz="1569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8" name="组合 137"/>
          <p:cNvGrpSpPr/>
          <p:nvPr/>
        </p:nvGrpSpPr>
        <p:grpSpPr>
          <a:xfrm>
            <a:off x="-20782" y="22041"/>
            <a:ext cx="12200848" cy="9326572"/>
            <a:chOff x="0" y="22041"/>
            <a:chExt cx="12200848" cy="9326572"/>
          </a:xfrm>
        </p:grpSpPr>
        <p:pic>
          <p:nvPicPr>
            <p:cNvPr id="154" name="图片 15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2041"/>
              <a:ext cx="6096000" cy="1219200"/>
            </a:xfrm>
            <a:prstGeom prst="rect">
              <a:avLst/>
            </a:prstGeom>
          </p:spPr>
        </p:pic>
        <p:sp>
          <p:nvSpPr>
            <p:cNvPr id="155" name="文本框 154"/>
            <p:cNvSpPr txBox="1"/>
            <p:nvPr/>
          </p:nvSpPr>
          <p:spPr>
            <a:xfrm>
              <a:off x="2024201" y="124782"/>
              <a:ext cx="8675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N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6" name="图片 15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22041"/>
              <a:ext cx="6096000" cy="1219200"/>
            </a:xfrm>
            <a:prstGeom prst="rect">
              <a:avLst/>
            </a:prstGeom>
          </p:spPr>
        </p:pic>
        <p:sp>
          <p:nvSpPr>
            <p:cNvPr id="157" name="文本框 156"/>
            <p:cNvSpPr txBox="1"/>
            <p:nvPr/>
          </p:nvSpPr>
          <p:spPr>
            <a:xfrm>
              <a:off x="8120971" y="124783"/>
              <a:ext cx="8675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N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58" name="图片 15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1169732"/>
              <a:ext cx="6095999" cy="1219200"/>
            </a:xfrm>
            <a:prstGeom prst="rect">
              <a:avLst/>
            </a:prstGeom>
          </p:spPr>
        </p:pic>
        <p:sp>
          <p:nvSpPr>
            <p:cNvPr id="159" name="文本框 158"/>
            <p:cNvSpPr txBox="1"/>
            <p:nvPr/>
          </p:nvSpPr>
          <p:spPr>
            <a:xfrm>
              <a:off x="2024200" y="1258443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N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0" name="图片 15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1169732"/>
              <a:ext cx="6096000" cy="1219200"/>
            </a:xfrm>
            <a:prstGeom prst="rect">
              <a:avLst/>
            </a:prstGeom>
          </p:spPr>
        </p:pic>
        <p:sp>
          <p:nvSpPr>
            <p:cNvPr id="161" name="文本框 160"/>
            <p:cNvSpPr txBox="1"/>
            <p:nvPr/>
          </p:nvSpPr>
          <p:spPr>
            <a:xfrm>
              <a:off x="8120200" y="1169734"/>
              <a:ext cx="8963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N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2" name="图片 16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2317423"/>
              <a:ext cx="6096000" cy="1219200"/>
            </a:xfrm>
            <a:prstGeom prst="rect">
              <a:avLst/>
            </a:prstGeom>
          </p:spPr>
        </p:pic>
        <p:sp>
          <p:nvSpPr>
            <p:cNvPr id="163" name="文本框 162"/>
            <p:cNvSpPr txBox="1"/>
            <p:nvPr/>
          </p:nvSpPr>
          <p:spPr>
            <a:xfrm>
              <a:off x="2024200" y="2393630"/>
              <a:ext cx="8755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N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4" name="图片 16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2317423"/>
              <a:ext cx="6096000" cy="1219200"/>
            </a:xfrm>
            <a:prstGeom prst="rect">
              <a:avLst/>
            </a:prstGeom>
          </p:spPr>
        </p:pic>
        <p:sp>
          <p:nvSpPr>
            <p:cNvPr id="165" name="文本框 164"/>
            <p:cNvSpPr txBox="1"/>
            <p:nvPr/>
          </p:nvSpPr>
          <p:spPr>
            <a:xfrm>
              <a:off x="8107105" y="2393632"/>
              <a:ext cx="8755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N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6" name="图片 16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3474598"/>
              <a:ext cx="6096000" cy="1219200"/>
            </a:xfrm>
            <a:prstGeom prst="rect">
              <a:avLst/>
            </a:prstGeom>
          </p:spPr>
        </p:pic>
        <p:sp>
          <p:nvSpPr>
            <p:cNvPr id="167" name="文本框 166"/>
            <p:cNvSpPr txBox="1"/>
            <p:nvPr/>
          </p:nvSpPr>
          <p:spPr>
            <a:xfrm>
              <a:off x="2016185" y="3529905"/>
              <a:ext cx="9044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N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8" name="图片 16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6000" y="3474598"/>
              <a:ext cx="6096000" cy="1219200"/>
            </a:xfrm>
            <a:prstGeom prst="rect">
              <a:avLst/>
            </a:prstGeom>
          </p:spPr>
        </p:pic>
        <p:sp>
          <p:nvSpPr>
            <p:cNvPr id="169" name="文本框 168"/>
            <p:cNvSpPr txBox="1"/>
            <p:nvPr/>
          </p:nvSpPr>
          <p:spPr>
            <a:xfrm>
              <a:off x="8116963" y="3529906"/>
              <a:ext cx="9044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N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0" name="图片 169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665605"/>
              <a:ext cx="6096000" cy="1219200"/>
            </a:xfrm>
            <a:prstGeom prst="rect">
              <a:avLst/>
            </a:prstGeom>
          </p:spPr>
        </p:pic>
        <p:sp>
          <p:nvSpPr>
            <p:cNvPr id="171" name="文本框 170"/>
            <p:cNvSpPr txBox="1"/>
            <p:nvPr/>
          </p:nvSpPr>
          <p:spPr>
            <a:xfrm>
              <a:off x="2053054" y="4666428"/>
              <a:ext cx="8531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T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2" name="图片 171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04022" y="4665605"/>
              <a:ext cx="6087978" cy="1217596"/>
            </a:xfrm>
            <a:prstGeom prst="rect">
              <a:avLst/>
            </a:prstGeom>
          </p:spPr>
        </p:pic>
        <p:sp>
          <p:nvSpPr>
            <p:cNvPr id="173" name="文本框 172"/>
            <p:cNvSpPr txBox="1"/>
            <p:nvPr/>
          </p:nvSpPr>
          <p:spPr>
            <a:xfrm>
              <a:off x="8158582" y="4666428"/>
              <a:ext cx="85311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BT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4" name="图片 173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22" y="5825982"/>
              <a:ext cx="6096000" cy="1219200"/>
            </a:xfrm>
            <a:prstGeom prst="rect">
              <a:avLst/>
            </a:prstGeom>
          </p:spPr>
        </p:pic>
        <p:sp>
          <p:nvSpPr>
            <p:cNvPr id="175" name="文本框 174"/>
            <p:cNvSpPr txBox="1"/>
            <p:nvPr/>
          </p:nvSpPr>
          <p:spPr>
            <a:xfrm>
              <a:off x="2049979" y="5863624"/>
              <a:ext cx="8819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T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6" name="图片 175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91989" y="5819857"/>
              <a:ext cx="6096000" cy="1219200"/>
            </a:xfrm>
            <a:prstGeom prst="rect">
              <a:avLst/>
            </a:prstGeom>
          </p:spPr>
        </p:pic>
        <p:sp>
          <p:nvSpPr>
            <p:cNvPr id="177" name="文本框 176"/>
            <p:cNvSpPr txBox="1"/>
            <p:nvPr/>
          </p:nvSpPr>
          <p:spPr>
            <a:xfrm>
              <a:off x="8156234" y="5863624"/>
              <a:ext cx="8819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MT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78" name="图片 177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50" y="6976324"/>
              <a:ext cx="6091989" cy="1218398"/>
            </a:xfrm>
            <a:prstGeom prst="rect">
              <a:avLst/>
            </a:prstGeom>
          </p:spPr>
        </p:pic>
        <p:sp>
          <p:nvSpPr>
            <p:cNvPr id="179" name="文本框 178"/>
            <p:cNvSpPr txBox="1"/>
            <p:nvPr/>
          </p:nvSpPr>
          <p:spPr>
            <a:xfrm>
              <a:off x="2031412" y="6988780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T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0" name="图片 179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08859" y="6967508"/>
              <a:ext cx="6091989" cy="1218398"/>
            </a:xfrm>
            <a:prstGeom prst="rect">
              <a:avLst/>
            </a:prstGeom>
          </p:spPr>
        </p:pic>
        <p:sp>
          <p:nvSpPr>
            <p:cNvPr id="181" name="文本框 180"/>
            <p:cNvSpPr txBox="1"/>
            <p:nvPr/>
          </p:nvSpPr>
          <p:spPr>
            <a:xfrm>
              <a:off x="8156234" y="6988780"/>
              <a:ext cx="8611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BT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2" name="图片 181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20" y="8115599"/>
              <a:ext cx="6085039" cy="1217008"/>
            </a:xfrm>
            <a:prstGeom prst="rect">
              <a:avLst/>
            </a:prstGeom>
          </p:spPr>
        </p:pic>
        <p:sp>
          <p:nvSpPr>
            <p:cNvPr id="183" name="文本框 182"/>
            <p:cNvSpPr txBox="1"/>
            <p:nvPr/>
          </p:nvSpPr>
          <p:spPr>
            <a:xfrm>
              <a:off x="2016185" y="8194339"/>
              <a:ext cx="889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T in 2019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84" name="图片 183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11792" y="8131605"/>
              <a:ext cx="6085039" cy="1217008"/>
            </a:xfrm>
            <a:prstGeom prst="rect">
              <a:avLst/>
            </a:prstGeom>
          </p:spPr>
        </p:pic>
        <p:sp>
          <p:nvSpPr>
            <p:cNvPr id="185" name="文本框 184"/>
            <p:cNvSpPr txBox="1"/>
            <p:nvPr/>
          </p:nvSpPr>
          <p:spPr>
            <a:xfrm>
              <a:off x="8101224" y="8188951"/>
              <a:ext cx="8899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MT in 2020</a:t>
              </a:r>
              <a:endParaRPr lang="zh-CN" alt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139" name="图片 138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354927"/>
            <a:ext cx="6115809" cy="1223162"/>
          </a:xfrm>
          <a:prstGeom prst="rect">
            <a:avLst/>
          </a:prstGeom>
        </p:spPr>
      </p:pic>
      <p:sp>
        <p:nvSpPr>
          <p:cNvPr id="140" name="文本框 139"/>
          <p:cNvSpPr txBox="1"/>
          <p:nvPr/>
        </p:nvSpPr>
        <p:spPr>
          <a:xfrm>
            <a:off x="2040242" y="9367663"/>
            <a:ext cx="8595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B in 2019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1" name="图片 14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9950" y="9354783"/>
            <a:ext cx="6103777" cy="1220755"/>
          </a:xfrm>
          <a:prstGeom prst="rect">
            <a:avLst/>
          </a:prstGeom>
        </p:spPr>
      </p:pic>
      <p:sp>
        <p:nvSpPr>
          <p:cNvPr id="142" name="文本框 141"/>
          <p:cNvSpPr txBox="1"/>
          <p:nvPr/>
        </p:nvSpPr>
        <p:spPr>
          <a:xfrm>
            <a:off x="8177889" y="9364480"/>
            <a:ext cx="8595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B in 202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3" name="图片 142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98" y="10508053"/>
            <a:ext cx="6119575" cy="1223915"/>
          </a:xfrm>
          <a:prstGeom prst="rect">
            <a:avLst/>
          </a:prstGeom>
        </p:spPr>
      </p:pic>
      <p:sp>
        <p:nvSpPr>
          <p:cNvPr id="144" name="文本框 143"/>
          <p:cNvSpPr txBox="1"/>
          <p:nvPr/>
        </p:nvSpPr>
        <p:spPr>
          <a:xfrm>
            <a:off x="2062683" y="10540032"/>
            <a:ext cx="888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M in 2019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6" name="图片 145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95" y="11665124"/>
            <a:ext cx="6103776" cy="1356395"/>
          </a:xfrm>
          <a:prstGeom prst="rect">
            <a:avLst/>
          </a:prstGeom>
        </p:spPr>
      </p:pic>
      <p:sp>
        <p:nvSpPr>
          <p:cNvPr id="147" name="文本框 146"/>
          <p:cNvSpPr txBox="1"/>
          <p:nvPr/>
        </p:nvSpPr>
        <p:spPr>
          <a:xfrm>
            <a:off x="2033829" y="11730209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 in 2019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8" name="图片 147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58391" y="11666383"/>
            <a:ext cx="6119575" cy="1359905"/>
          </a:xfrm>
          <a:prstGeom prst="rect">
            <a:avLst/>
          </a:prstGeom>
        </p:spPr>
      </p:pic>
      <p:sp>
        <p:nvSpPr>
          <p:cNvPr id="149" name="文本框 148"/>
          <p:cNvSpPr txBox="1"/>
          <p:nvPr/>
        </p:nvSpPr>
        <p:spPr>
          <a:xfrm>
            <a:off x="8210451" y="11730208"/>
            <a:ext cx="8675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B in 202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0" name="图片 149"/>
          <p:cNvPicPr>
            <a:picLocks noChangeAspect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93" y="12995823"/>
            <a:ext cx="6119575" cy="1359905"/>
          </a:xfrm>
          <a:prstGeom prst="rect">
            <a:avLst/>
          </a:prstGeom>
        </p:spPr>
      </p:pic>
      <p:sp>
        <p:nvSpPr>
          <p:cNvPr id="151" name="文本框 150"/>
          <p:cNvSpPr txBox="1"/>
          <p:nvPr/>
        </p:nvSpPr>
        <p:spPr>
          <a:xfrm>
            <a:off x="1974519" y="13041112"/>
            <a:ext cx="8963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 in 2019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52" name="图片 151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1727" y="12982869"/>
            <a:ext cx="6069582" cy="1348796"/>
          </a:xfrm>
          <a:prstGeom prst="rect">
            <a:avLst/>
          </a:prstGeom>
        </p:spPr>
      </p:pic>
      <p:sp>
        <p:nvSpPr>
          <p:cNvPr id="153" name="文本框 152"/>
          <p:cNvSpPr txBox="1"/>
          <p:nvPr/>
        </p:nvSpPr>
        <p:spPr>
          <a:xfrm>
            <a:off x="8221129" y="13041089"/>
            <a:ext cx="8963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M in 202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88" name="图片 187"/>
          <p:cNvPicPr>
            <a:picLocks noChangeAspect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73675" y="10658684"/>
            <a:ext cx="6096000" cy="908383"/>
          </a:xfrm>
          <a:prstGeom prst="rect">
            <a:avLst/>
          </a:prstGeom>
        </p:spPr>
      </p:pic>
      <p:sp>
        <p:nvSpPr>
          <p:cNvPr id="189" name="文本框 188"/>
          <p:cNvSpPr txBox="1"/>
          <p:nvPr/>
        </p:nvSpPr>
        <p:spPr>
          <a:xfrm>
            <a:off x="8210710" y="10547990"/>
            <a:ext cx="8883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CM in 2020</a:t>
            </a:r>
            <a:endParaRPr lang="zh-CN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413316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228</Words>
  <Application>Microsoft Macintosh PowerPoint</Application>
  <PresentationFormat>自定义</PresentationFormat>
  <Paragraphs>2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邱先进</dc:creator>
  <cp:lastModifiedBy>Microsoft Office 用户</cp:lastModifiedBy>
  <cp:revision>10</cp:revision>
  <dcterms:created xsi:type="dcterms:W3CDTF">2021-10-04T01:57:56Z</dcterms:created>
  <dcterms:modified xsi:type="dcterms:W3CDTF">2022-07-30T12:32:22Z</dcterms:modified>
</cp:coreProperties>
</file>